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619"/>
    <p:restoredTop sz="92197"/>
  </p:normalViewPr>
  <p:slideViewPr>
    <p:cSldViewPr snapToGrid="0" snapToObjects="1">
      <p:cViewPr varScale="1">
        <p:scale>
          <a:sx n="56" d="100"/>
          <a:sy n="56" d="100"/>
        </p:scale>
        <p:origin x="6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6AD7162-6EA6-5946-8786-EB572FC3FE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9A0DAE8-523E-2F4A-895D-84799FE75C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0630C11-EAC0-4440-B97B-128243A42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1EA170-365A-3C4B-B348-E9998FFF9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6C4606-6AAF-1349-9808-5D51FC1D5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974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FC009B2-5264-1D4C-8BF6-8DB5C7064A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8382361-2814-2448-8C28-9A126934FB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43F347D-85EA-A248-BA27-FBCE10D47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64E9B64-8010-ED48-9AA3-CFF3B9876C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1E2035B-118D-F54A-BA24-28CBB2B36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4863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7338A2E-F74A-8942-B02E-C4F00F8869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BB4A73B-CC25-A745-9C86-78BAA3D8EC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0D4ADB-4056-5546-AE22-C40324D35F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13A4D9-9C46-144B-BFE5-E9023A986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EFACCF-0661-FF45-A55D-BF73B037BD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5626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EA3111-DE11-E545-9AE1-E09E328196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A217C79-F1AD-2A42-9390-39977350CE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9B3F9BC-EF95-2B4B-BB5C-CA7CF58B5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7F0C061-0FF9-D349-AAB5-5236911C6F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864966-A00C-BE4B-B90E-93D5F0D712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503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68DD1A-1A05-F24E-A757-C5E965780F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C96BAF-FDB0-024C-8418-601F6FA72C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C27A8AA-A280-3F43-BBAC-A2E6FCA7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9DE8EA1-A14A-8549-ADBF-F7E87C0851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23EB3F-18F9-1142-AD9E-9ECED6B412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492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09CC46-7179-D349-A1D1-3CD5F35BD9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3158AA1-2C25-2F4A-B457-6E5DCEB6E06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9957F92-4CFC-694D-AEB7-6FE1AB01D55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440521-F5CA-5C44-91D4-DE2059C80E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F96B49C-CAF5-5440-A643-A3680EB49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7C10D9-8717-8E40-BF94-9F9FA818C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921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EB26B8-E38E-F646-9620-DF7C0D16A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60EEDC0-7496-444D-A04A-B825C7A63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2ABCDBD-1EC3-8E47-9CD5-A5077C766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0683966-DE0B-0140-888A-0CCA85FA64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26B6405-241E-C64C-88B6-91CC4F7359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8FB7044-B213-8A46-95E8-0D0B32D2B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A4332A2-C565-754E-956C-14FDDA1EC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049C3FD-B3C6-3946-8CF1-4A2A8CBC15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0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801C81-0F24-8F4A-AB15-AB18C5FC4B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49748CA-5EC7-8948-900A-66FBE4F9F1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904C2FE-6692-F94F-B030-468C4D6E84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1031C042-D0C0-2149-9713-B594B6007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564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20DCAC3-9BE7-0B4B-96B3-57D450E961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819A78F-D0F0-5A41-8999-791084A75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7848F5A-C4AE-6544-BFE8-769FEF521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628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C3FF58-DEAC-0A49-8411-880691A14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D10BDC2-B33F-3349-963A-50FA0A53CD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A038DAC-A517-914D-86F2-F53F3A2892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9FCBDC3-806D-7642-9BE5-200338486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1C9485-2695-6543-B699-20B4A657E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AE39647-DFB2-ED4F-9B55-C5163384B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156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0C182D4-1088-2045-AE84-E7FFA90B6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ABCA0E7-3EB2-C149-AA8B-11281A5025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7553001-E5F4-A44E-9131-1681673F3E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7B02DB4-55A3-1C40-9868-FBB323C4E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F1C488-BCE3-504D-83AE-3D10181D5E1D}" type="datetimeFigureOut">
              <a:rPr kumimoji="1" lang="ja-JP" altLang="en-US" smtClean="0"/>
              <a:t>2024/2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4294C7-1960-CF43-B825-7B6A2234C1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D9F578-407D-7C45-9E0D-3CA771C824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F0FFBC-D4C0-0A48-9985-962C9B3C4CB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2506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DAE1B3-A09B-1B48-A297-8E01EB009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8944210-8667-2045-92F8-82F4A2D7EF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11550D-6142-2C4C-84F8-1AF4EBC509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46F1C488-BCE3-504D-83AE-3D10181D5E1D}" type="datetimeFigureOut">
              <a:rPr lang="ja-JP" altLang="en-US" smtClean="0"/>
              <a:pPr/>
              <a:t>2024/2/14</a:t>
            </a:fld>
            <a:endParaRPr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B30E0D6-FE9A-1849-8044-22B197E14B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B97180-1BBC-0049-A536-D9BA9879B9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69F0FFBC-D4C0-0A48-9985-962C9B3C4CB8}" type="slidenum">
              <a:rPr lang="ja-JP" altLang="en-US" smtClean="0"/>
              <a:pPr/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3758144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Meiryo" panose="020B0604030504040204" pitchFamily="34" charset="-128"/>
          <a:ea typeface="Meiryo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232EAD2-6C89-B34E-8DD7-0443F88EDD8A}"/>
              </a:ext>
            </a:extLst>
          </p:cNvPr>
          <p:cNvSpPr txBox="1"/>
          <p:nvPr/>
        </p:nvSpPr>
        <p:spPr>
          <a:xfrm>
            <a:off x="1806261" y="93102"/>
            <a:ext cx="80457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Changes in </a:t>
            </a:r>
            <a:r>
              <a:rPr lang="en-US" altLang="ja-JP" u="sng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phate</a:t>
            </a:r>
            <a:r>
              <a:rPr lang="en-US" altLang="ja-JP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after denosumab administration</a:t>
            </a:r>
            <a:endParaRPr kumimoji="1" lang="ja-JP" altLang="en-US" u="sng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F01E147C-392D-3C4F-8E46-713A6B795A55}"/>
              </a:ext>
            </a:extLst>
          </p:cNvPr>
          <p:cNvGrpSpPr/>
          <p:nvPr/>
        </p:nvGrpSpPr>
        <p:grpSpPr>
          <a:xfrm>
            <a:off x="1111802" y="894522"/>
            <a:ext cx="8533904" cy="5956662"/>
            <a:chOff x="1111802" y="894522"/>
            <a:chExt cx="8533904" cy="5956662"/>
          </a:xfrm>
        </p:grpSpPr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590A5221-12B1-DB4A-89EF-9A008CC92D85}"/>
                </a:ext>
              </a:extLst>
            </p:cNvPr>
            <p:cNvSpPr/>
            <p:nvPr/>
          </p:nvSpPr>
          <p:spPr>
            <a:xfrm rot="16200000">
              <a:off x="-904322" y="3225935"/>
              <a:ext cx="4495799" cy="46355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ja-JP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e levels (</a:t>
              </a:r>
              <a:r>
                <a:rPr kumimoji="1" lang="en-US" altLang="ja-JP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g</a:t>
              </a:r>
              <a:r>
                <a:rPr lang="en-US" altLang="ja-JP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kumimoji="1" lang="en-US" altLang="ja-JP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r>
                <a:rPr lang="en-US" altLang="ja-JP" dirty="0" err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lang="en-US" altLang="ja-JP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1" lang="ja-JP" altLang="en-US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C564A68C-DB6F-A74C-AC39-F91229E4E146}"/>
                </a:ext>
              </a:extLst>
            </p:cNvPr>
            <p:cNvSpPr txBox="1"/>
            <p:nvPr/>
          </p:nvSpPr>
          <p:spPr>
            <a:xfrm>
              <a:off x="4145482" y="6481852"/>
              <a:ext cx="36407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ys after </a:t>
              </a:r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nosumab administration</a:t>
              </a:r>
              <a:endParaRPr kumimoji="1" lang="ja-JP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B0C4136-AF11-5D42-8227-9F145D5A8F11}"/>
                </a:ext>
              </a:extLst>
            </p:cNvPr>
            <p:cNvSpPr txBox="1"/>
            <p:nvPr/>
          </p:nvSpPr>
          <p:spPr>
            <a:xfrm>
              <a:off x="2285999" y="6112520"/>
              <a:ext cx="73597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e             7              14             30             60            120           180           360</a:t>
              </a:r>
            </a:p>
          </p:txBody>
        </p:sp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B3851DBF-86AD-884D-9C09-F2D282D34254}"/>
                </a:ext>
              </a:extLst>
            </p:cNvPr>
            <p:cNvSpPr/>
            <p:nvPr/>
          </p:nvSpPr>
          <p:spPr>
            <a:xfrm>
              <a:off x="4472609" y="894522"/>
              <a:ext cx="2623930" cy="25841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AFA77247-6835-5E46-BAAA-5C8588800B2F}"/>
              </a:ext>
            </a:extLst>
          </p:cNvPr>
          <p:cNvSpPr/>
          <p:nvPr/>
        </p:nvSpPr>
        <p:spPr>
          <a:xfrm>
            <a:off x="9645707" y="1749287"/>
            <a:ext cx="412693" cy="2673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A7D38D90-5B19-EB4D-A8A3-95C15CC0B1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466"/>
          <a:stretch/>
        </p:blipFill>
        <p:spPr>
          <a:xfrm>
            <a:off x="1545536" y="434201"/>
            <a:ext cx="8450120" cy="56252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072021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C9DF33FA-C216-FC4A-9A77-53C2FAB637B0}" vid="{D8C45B50-8ECB-684F-B49B-15C1275691BF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テーマ1</Template>
  <TotalTime>629</TotalTime>
  <Words>30</Words>
  <Application>Microsoft Macintosh PowerPoint</Application>
  <PresentationFormat>ワイド画面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</vt:lpstr>
      <vt:lpstr>游ゴシック</vt:lpstr>
      <vt:lpstr>Arial</vt:lpstr>
      <vt:lpstr>Times New Roman</vt:lpstr>
      <vt:lpstr>テーマ1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加藤 一彦</dc:creator>
  <cp:lastModifiedBy>加藤 一彦</cp:lastModifiedBy>
  <cp:revision>96</cp:revision>
  <cp:lastPrinted>2023-12-21T08:00:09Z</cp:lastPrinted>
  <dcterms:created xsi:type="dcterms:W3CDTF">2023-10-10T05:47:52Z</dcterms:created>
  <dcterms:modified xsi:type="dcterms:W3CDTF">2024-02-14T02:57:10Z</dcterms:modified>
</cp:coreProperties>
</file>